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248150" cy="3455988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C10593-226E-4ECD-8D0D-A4958E453E9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12400" y="138240"/>
            <a:ext cx="3822840" cy="5760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12400" y="806040"/>
            <a:ext cx="382284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12400" y="1997640"/>
            <a:ext cx="382284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BED99-EB59-434C-9CB8-32B8AE266F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12400" y="138240"/>
            <a:ext cx="3822840" cy="5760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12400" y="806040"/>
            <a:ext cx="186552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171520" y="806040"/>
            <a:ext cx="186552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12400" y="1997640"/>
            <a:ext cx="186552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171520" y="1997640"/>
            <a:ext cx="186552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9EC90-3FD0-4583-ABE1-DBDF05E58E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12400" y="138240"/>
            <a:ext cx="3822840" cy="5760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12400" y="806040"/>
            <a:ext cx="123084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05160" y="806040"/>
            <a:ext cx="123084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797920" y="806040"/>
            <a:ext cx="123084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12400" y="1997640"/>
            <a:ext cx="123084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05160" y="1997640"/>
            <a:ext cx="123084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797920" y="1997640"/>
            <a:ext cx="123084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22FAA-B3E9-4552-809E-9C4CB0225A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12400" y="138240"/>
            <a:ext cx="3822840" cy="5760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12400" y="806040"/>
            <a:ext cx="3822840" cy="228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74"/>
              </a:spcBef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758D8-180F-42B6-A6F7-E3CC606E45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12400" y="138240"/>
            <a:ext cx="3822840" cy="5760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12400" y="806040"/>
            <a:ext cx="3822840" cy="22813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D8D96-BACF-4F20-AFAC-AD9010E9B5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12400" y="138240"/>
            <a:ext cx="3822840" cy="5760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12400" y="806040"/>
            <a:ext cx="1865520" cy="22813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171520" y="806040"/>
            <a:ext cx="1865520" cy="22813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8C061B-D506-4918-AA60-94BF7BB440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12400" y="138240"/>
            <a:ext cx="3822840" cy="5760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8735E4-067F-4199-9870-F3CBF78500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12400" y="138240"/>
            <a:ext cx="3822840" cy="267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74"/>
              </a:spcBef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03C4E-C796-4431-8438-91D03C2B7A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12400" y="138240"/>
            <a:ext cx="3822840" cy="5760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12400" y="806040"/>
            <a:ext cx="186552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171520" y="806040"/>
            <a:ext cx="1865520" cy="22813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12400" y="1997640"/>
            <a:ext cx="186552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834AD7-7FA4-4863-80EC-42596726FC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12400" y="138240"/>
            <a:ext cx="3822840" cy="5760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12400" y="806040"/>
            <a:ext cx="1865520" cy="22813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171520" y="806040"/>
            <a:ext cx="186552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171520" y="1997640"/>
            <a:ext cx="186552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A2855-03F9-4131-A2ED-A4782569CD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12400" y="138240"/>
            <a:ext cx="3822840" cy="5760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12400" y="806040"/>
            <a:ext cx="186552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171520" y="806040"/>
            <a:ext cx="186552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12400" y="1997640"/>
            <a:ext cx="3822840" cy="10879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indent="0">
              <a:spcBef>
                <a:spcPts val="374"/>
              </a:spcBef>
              <a:buNone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05ACF4-6AAE-4C48-94CC-69038B7E71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12400" y="138240"/>
            <a:ext cx="3822840" cy="5760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ctr">
            <a:noAutofit/>
          </a:bodyPr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12400" y="806040"/>
            <a:ext cx="3822840" cy="228132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rmAutofit/>
          </a:bodyPr>
          <a:p>
            <a:pPr marL="157320" indent="-157320">
              <a:spcBef>
                <a:spcPts val="374"/>
              </a:spcBef>
              <a:buClr>
                <a:srgbClr val="000000"/>
              </a:buClr>
              <a:buFont typeface="Arial"/>
              <a:buChar char="•"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1" marL="339840" indent="-130320">
              <a:spcBef>
                <a:spcPts val="374"/>
              </a:spcBef>
              <a:buClr>
                <a:srgbClr val="000000"/>
              </a:buClr>
              <a:buFont typeface="Arial"/>
              <a:buChar char="–"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2" marL="522360" indent="-103320">
              <a:spcBef>
                <a:spcPts val="374"/>
              </a:spcBef>
              <a:buClr>
                <a:srgbClr val="000000"/>
              </a:buClr>
              <a:buFont typeface="Arial"/>
              <a:buChar char="•"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3" marL="731880" indent="-104760">
              <a:spcBef>
                <a:spcPts val="374"/>
              </a:spcBef>
              <a:buClr>
                <a:srgbClr val="000000"/>
              </a:buClr>
              <a:buFont typeface="Arial"/>
              <a:buChar char="–"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4" marL="941400" indent="-10476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5" marL="941400" indent="-10476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lvl="6" marL="941400" indent="-104760">
              <a:spcBef>
                <a:spcPts val="374"/>
              </a:spcBef>
              <a:buClr>
                <a:srgbClr val="000000"/>
              </a:buClr>
              <a:buFont typeface="Arial"/>
              <a:buChar char="»"/>
              <a:tabLst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12760" y="3146400"/>
            <a:ext cx="990720" cy="241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Autofit/>
          </a:bodyPr>
          <a:lstStyle>
            <a:lvl1pPr indent="0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  <a:defRPr b="0" lang="en-GB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50800" y="3146400"/>
            <a:ext cx="1346400" cy="241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Autofit/>
          </a:bodyPr>
          <a:lstStyle>
            <a:lvl1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  <a:defRPr b="0" lang="en-GB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044880" y="3146400"/>
            <a:ext cx="990720" cy="241200"/>
          </a:xfrm>
          <a:prstGeom prst="rect">
            <a:avLst/>
          </a:prstGeom>
          <a:noFill/>
          <a:ln w="0">
            <a:noFill/>
          </a:ln>
        </p:spPr>
        <p:txBody>
          <a:bodyPr lIns="41760" rIns="41760" tIns="20880" bIns="20880" anchor="t">
            <a:noAutofit/>
          </a:bodyPr>
          <a:lstStyle>
            <a:lvl1pPr indent="0" algn="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  <a:defRPr b="0" lang="en-GB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19040"/>
                <a:tab algn="l" pos="838080"/>
                <a:tab algn="l" pos="1257480"/>
                <a:tab algn="l" pos="1676520"/>
                <a:tab algn="l" pos="2095560"/>
                <a:tab algn="l" pos="2514600"/>
                <a:tab algn="l" pos="2933640"/>
                <a:tab algn="l" pos="3352680"/>
                <a:tab algn="l" pos="3772080"/>
                <a:tab algn="l" pos="4191120"/>
                <a:tab algn="l" pos="4610160"/>
                <a:tab algn="l" pos="5029200"/>
                <a:tab algn="l" pos="5448240"/>
                <a:tab algn="l" pos="5867280"/>
                <a:tab algn="l" pos="6286680"/>
                <a:tab algn="l" pos="6705720"/>
                <a:tab algn="l" pos="7124760"/>
                <a:tab algn="l" pos="7543800"/>
                <a:tab algn="l" pos="7962840"/>
                <a:tab algn="l" pos="8381880"/>
              </a:tabLst>
            </a:pPr>
            <a:fld id="{E27B8B92-CF4B-4307-A2BF-2343310485E4}" type="slidenum">
              <a:rPr b="0" lang="en-GB" sz="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92200" y="912960"/>
            <a:ext cx="249120" cy="14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671040" y="7286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0240" y="1959120"/>
            <a:ext cx="293760" cy="36648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flipH="1">
            <a:off x="1573200" y="569880"/>
            <a:ext cx="193680" cy="665280"/>
          </a:xfrm>
          <a:prstGeom prst="line">
            <a:avLst/>
          </a:prstGeom>
          <a:ln cap="sq" w="15840">
            <a:solidFill>
              <a:srgbClr val="33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7601600">
            <a:off x="1636560" y="283680"/>
            <a:ext cx="438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2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flipH="1">
            <a:off x="1992240" y="455760"/>
            <a:ext cx="162000" cy="569880"/>
          </a:xfrm>
          <a:prstGeom prst="line">
            <a:avLst/>
          </a:prstGeom>
          <a:ln cap="sq" w="15840">
            <a:solidFill>
              <a:srgbClr val="33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7883600">
            <a:off x="2046600" y="217080"/>
            <a:ext cx="354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2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flipH="1">
            <a:off x="1991880" y="781200"/>
            <a:ext cx="397080" cy="244440"/>
          </a:xfrm>
          <a:prstGeom prst="line">
            <a:avLst/>
          </a:prstGeom>
          <a:ln cap="sq" w="15840">
            <a:solidFill>
              <a:srgbClr val="33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9801200">
            <a:off x="2373480" y="593280"/>
            <a:ext cx="53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2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H="1">
            <a:off x="1573200" y="1025640"/>
            <a:ext cx="419040" cy="209520"/>
          </a:xfrm>
          <a:prstGeom prst="line">
            <a:avLst/>
          </a:prstGeom>
          <a:ln cap="sq" w="15840">
            <a:solidFill>
              <a:srgbClr val="33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H="1">
            <a:off x="1174320" y="1235160"/>
            <a:ext cx="398520" cy="495360"/>
          </a:xfrm>
          <a:prstGeom prst="line">
            <a:avLst/>
          </a:prstGeom>
          <a:ln cap="sq" w="15840">
            <a:solidFill>
              <a:srgbClr val="33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H="1">
            <a:off x="1739520" y="1123920"/>
            <a:ext cx="825480" cy="48564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9569000">
            <a:off x="2547000" y="919080"/>
            <a:ext cx="53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1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>
            <a:off x="2298600" y="1473120"/>
            <a:ext cx="330480" cy="19548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9945200">
            <a:off x="2617200" y="1304640"/>
            <a:ext cx="482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1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H="1">
            <a:off x="2630520" y="1685880"/>
            <a:ext cx="69840" cy="6048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9744800">
            <a:off x="2688480" y="1522080"/>
            <a:ext cx="399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1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H="1" flipV="1">
            <a:off x="2630520" y="1746000"/>
            <a:ext cx="109440" cy="1404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769840" y="1724040"/>
            <a:ext cx="308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1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H="1" flipV="1">
            <a:off x="2298600" y="1668600"/>
            <a:ext cx="331920" cy="7776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H="1" flipV="1">
            <a:off x="1739880" y="1609560"/>
            <a:ext cx="558720" cy="5904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1174680" y="1609560"/>
            <a:ext cx="565200" cy="12096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828360" y="1730520"/>
            <a:ext cx="345960" cy="30456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H="1">
            <a:off x="1376280" y="2017800"/>
            <a:ext cx="733680" cy="6804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21420000">
            <a:off x="2136960" y="1960200"/>
            <a:ext cx="53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H="1">
            <a:off x="1749600" y="2122560"/>
            <a:ext cx="723600" cy="25380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21159600">
            <a:off x="2499120" y="2049480"/>
            <a:ext cx="354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2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H="1">
            <a:off x="2590560" y="2190600"/>
            <a:ext cx="191880" cy="16848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826360" y="2120760"/>
            <a:ext cx="460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Gold fish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H="1">
            <a:off x="2590560" y="2325600"/>
            <a:ext cx="339480" cy="3348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968560" y="2289240"/>
            <a:ext cx="474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flipH="1">
            <a:off x="2095560" y="2359080"/>
            <a:ext cx="495360" cy="25092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H="1">
            <a:off x="2440080" y="2577960"/>
            <a:ext cx="536400" cy="19368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008520" y="2535120"/>
            <a:ext cx="601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inbow trout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H="1">
            <a:off x="2901600" y="2827440"/>
            <a:ext cx="507960" cy="29844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448800" y="2773440"/>
            <a:ext cx="354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H="1" flipV="1">
            <a:off x="2901960" y="3125880"/>
            <a:ext cx="542880" cy="21744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483000" y="3301920"/>
            <a:ext cx="730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Japanese flounder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H="1" flipV="1">
            <a:off x="2439720" y="2771640"/>
            <a:ext cx="461880" cy="35424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H="1" flipV="1">
            <a:off x="2095200" y="2609640"/>
            <a:ext cx="344520" cy="16164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H="1" flipV="1">
            <a:off x="1749240" y="2376000"/>
            <a:ext cx="345960" cy="23364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H="1" flipV="1">
            <a:off x="1375920" y="2085480"/>
            <a:ext cx="373320" cy="29052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H="1" flipV="1">
            <a:off x="828360" y="2034720"/>
            <a:ext cx="547560" cy="5076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H="1">
            <a:off x="331560" y="2039760"/>
            <a:ext cx="493560" cy="27792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518920" y="17524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199960" y="16714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698120" y="16225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155240" y="17384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561680" y="12384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974600" y="10368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5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331720" y="27702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569680" y="23623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296720" y="20970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677600" y="23814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022120" y="26146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5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731520" y="19540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8T11:25:08Z</dcterms:created>
  <dc:creator>Nicholas David Temperley</dc:creator>
  <dc:description/>
  <dc:language>en-US</dc:language>
  <cp:lastModifiedBy>Nicholas David Temperley</cp:lastModifiedBy>
  <dcterms:modified xsi:type="dcterms:W3CDTF">2008-01-31T15:42:07Z</dcterms:modified>
  <cp:revision>31</cp:revision>
  <dc:subject/>
  <dc:title>Slide 1</dc:title>
</cp:coreProperties>
</file>